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84F9DC-1FC9-4E60-AA90-E747C28978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AC9A2-4D02-4E97-A9FC-B2ADA9E91E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77B633-044E-4A77-9281-494BB2B231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8CD0F-B2AF-4B8D-9382-0E6656A11C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86E3F-E7FC-4801-8781-1C6E23ED31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B48F28-1823-440A-AFE5-B391B62077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5C8DEC-64AC-4452-B411-486E607B55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022B99-4D8B-4F97-B85A-BE4AEA075D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F1FEC-9CF8-44FC-875D-06C3B7B120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045825-9244-4605-AB82-2AE1B29F8D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B97EF-BECB-4814-82A4-E8CE6B9E14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97957A-B38B-44AA-8688-1C67BE417D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F217FE-BDCB-48FE-820E-A07034792FB0}" type="slidenum"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39640" y="0"/>
            <a:ext cx="7345440" cy="3213000"/>
            <a:chOff x="539640" y="0"/>
            <a:chExt cx="7345440" cy="3213000"/>
          </a:xfrm>
        </p:grpSpPr>
        <p:graphicFrame>
          <p:nvGraphicFramePr>
            <p:cNvPr id="42" name=""/>
            <p:cNvGraphicFramePr/>
            <p:nvPr/>
          </p:nvGraphicFramePr>
          <p:xfrm>
            <a:off x="539640" y="0"/>
            <a:ext cx="7345440" cy="321300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539640" y="0"/>
                      <a:ext cx="7345440" cy="3213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"/>
            <p:cNvSpPr/>
            <p:nvPr/>
          </p:nvSpPr>
          <p:spPr>
            <a:xfrm>
              <a:off x="7741080" y="51480"/>
              <a:ext cx="0" cy="298620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5" name=""/>
          <p:cNvSpPr/>
          <p:nvPr/>
        </p:nvSpPr>
        <p:spPr>
          <a:xfrm>
            <a:off x="8246160" y="6192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494160" y="1555920"/>
            <a:ext cx="1704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</a:rPr>
              <a:t>Subject #1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7" name=""/>
          <p:cNvGrpSpPr/>
          <p:nvPr/>
        </p:nvGrpSpPr>
        <p:grpSpPr>
          <a:xfrm>
            <a:off x="539640" y="3645000"/>
            <a:ext cx="7417080" cy="3213000"/>
            <a:chOff x="539640" y="3645000"/>
            <a:chExt cx="7417080" cy="3213000"/>
          </a:xfrm>
        </p:grpSpPr>
        <p:graphicFrame>
          <p:nvGraphicFramePr>
            <p:cNvPr id="48" name=""/>
            <p:cNvGraphicFramePr/>
            <p:nvPr/>
          </p:nvGraphicFramePr>
          <p:xfrm>
            <a:off x="539640" y="3645000"/>
            <a:ext cx="7417080" cy="321300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9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39640" y="3645000"/>
                      <a:ext cx="7417080" cy="3213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0" name=""/>
            <p:cNvSpPr/>
            <p:nvPr/>
          </p:nvSpPr>
          <p:spPr>
            <a:xfrm>
              <a:off x="6058440" y="3701520"/>
              <a:ext cx="0" cy="298692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1" name=""/>
          <p:cNvSpPr/>
          <p:nvPr/>
        </p:nvSpPr>
        <p:spPr>
          <a:xfrm>
            <a:off x="8246160" y="314172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3637080" y="3716280"/>
            <a:ext cx="1704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</a:rPr>
              <a:t>Subject #2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 rot="16200000">
            <a:off x="-1012320" y="1382040"/>
            <a:ext cx="26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HCV effective population size (Ne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-869400" y="4983120"/>
            <a:ext cx="266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HCV effective population size (Ne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"/>
          <p:cNvGrpSpPr/>
          <p:nvPr/>
        </p:nvGrpSpPr>
        <p:grpSpPr>
          <a:xfrm>
            <a:off x="755640" y="0"/>
            <a:ext cx="7201080" cy="2852640"/>
            <a:chOff x="755640" y="0"/>
            <a:chExt cx="7201080" cy="2852640"/>
          </a:xfrm>
        </p:grpSpPr>
        <p:graphicFrame>
          <p:nvGraphicFramePr>
            <p:cNvPr id="56" name=""/>
            <p:cNvGraphicFramePr/>
            <p:nvPr/>
          </p:nvGraphicFramePr>
          <p:xfrm>
            <a:off x="755640" y="0"/>
            <a:ext cx="7201080" cy="28526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57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755640" y="0"/>
                      <a:ext cx="7201080" cy="2852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8" name=""/>
            <p:cNvSpPr/>
            <p:nvPr/>
          </p:nvSpPr>
          <p:spPr>
            <a:xfrm>
              <a:off x="6511320" y="50760"/>
              <a:ext cx="0" cy="265140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9" name=""/>
          <p:cNvSpPr/>
          <p:nvPr/>
        </p:nvSpPr>
        <p:spPr>
          <a:xfrm>
            <a:off x="8390520" y="4762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2845080" y="1698480"/>
            <a:ext cx="1704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</a:rPr>
              <a:t>Subject #6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61" name=""/>
          <p:cNvGrpSpPr/>
          <p:nvPr/>
        </p:nvGrpSpPr>
        <p:grpSpPr>
          <a:xfrm>
            <a:off x="755640" y="3618000"/>
            <a:ext cx="7129440" cy="3240000"/>
            <a:chOff x="755640" y="3618000"/>
            <a:chExt cx="7129440" cy="3240000"/>
          </a:xfrm>
        </p:grpSpPr>
        <p:graphicFrame>
          <p:nvGraphicFramePr>
            <p:cNvPr id="62" name=""/>
            <p:cNvGraphicFramePr/>
            <p:nvPr/>
          </p:nvGraphicFramePr>
          <p:xfrm>
            <a:off x="755640" y="3618000"/>
            <a:ext cx="7129440" cy="324000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63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755640" y="3618000"/>
                      <a:ext cx="7129440" cy="32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4" name=""/>
            <p:cNvSpPr/>
            <p:nvPr/>
          </p:nvSpPr>
          <p:spPr>
            <a:xfrm>
              <a:off x="7632360" y="3674880"/>
              <a:ext cx="0" cy="301140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5" name=""/>
          <p:cNvSpPr/>
          <p:nvPr/>
        </p:nvSpPr>
        <p:spPr>
          <a:xfrm>
            <a:off x="8390520" y="386064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3278520" y="3716280"/>
            <a:ext cx="1704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</a:rPr>
              <a:t>Subject #8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 rot="16200000">
            <a:off x="-798120" y="1193760"/>
            <a:ext cx="266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HCV effective population size (Ne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-725040" y="4910040"/>
            <a:ext cx="266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HCV effective population size (Ne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"/>
          <p:cNvSpPr/>
          <p:nvPr/>
        </p:nvSpPr>
        <p:spPr>
          <a:xfrm>
            <a:off x="8461440" y="33192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Times New Roman"/>
              </a:rPr>
              <a:t>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0" name=""/>
          <p:cNvGrpSpPr/>
          <p:nvPr/>
        </p:nvGrpSpPr>
        <p:grpSpPr>
          <a:xfrm>
            <a:off x="971640" y="260280"/>
            <a:ext cx="6913440" cy="3492000"/>
            <a:chOff x="971640" y="260280"/>
            <a:chExt cx="6913440" cy="3492000"/>
          </a:xfrm>
        </p:grpSpPr>
        <p:graphicFrame>
          <p:nvGraphicFramePr>
            <p:cNvPr id="71" name=""/>
            <p:cNvGraphicFramePr/>
            <p:nvPr/>
          </p:nvGraphicFramePr>
          <p:xfrm>
            <a:off x="971640" y="260280"/>
            <a:ext cx="6913440" cy="30632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72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971640" y="260280"/>
                      <a:ext cx="6913440" cy="3063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3" name=""/>
            <p:cNvSpPr/>
            <p:nvPr/>
          </p:nvSpPr>
          <p:spPr>
            <a:xfrm>
              <a:off x="3406320" y="307080"/>
              <a:ext cx="0" cy="297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225600" y="3292560"/>
              <a:ext cx="51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T0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75" name=""/>
          <p:cNvSpPr/>
          <p:nvPr/>
        </p:nvSpPr>
        <p:spPr>
          <a:xfrm>
            <a:off x="5078880" y="2205000"/>
            <a:ext cx="1873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</a:rPr>
              <a:t>Subject #10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 rot="16200000">
            <a:off x="-653760" y="1527120"/>
            <a:ext cx="266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HCV effective population size (Ne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7T11:25:58Z</dcterms:created>
  <dc:creator>FBernini</dc:creator>
  <dc:description/>
  <dc:language>en-US</dc:language>
  <cp:lastModifiedBy> </cp:lastModifiedBy>
  <dcterms:modified xsi:type="dcterms:W3CDTF">2010-08-11T13:26:45Z</dcterms:modified>
  <cp:revision>23</cp:revision>
  <dc:subject/>
  <dc:title>Presentazione di PowerPoint</dc:title>
</cp:coreProperties>
</file>